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5FC21-8BA3-43CA-AFBE-63A8D63713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35740-AEC2-407B-9607-8D2B59DE4F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6ED261-EB50-41CF-BF87-A8A2B6CF7B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37FFE-024A-4FD3-BF22-B11BE9B89A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6750A-7711-4464-BE51-572C8552E0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0FEB83-0DF3-4570-8863-A436E92AAB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4A18A-B33F-4C39-A24A-AC64DADF6D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DC007-6A70-4255-B697-D31E666068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91712-859B-48C5-9BC7-412CA6D0C8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CE8E33-1A09-468F-BB95-960D1D2E3F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F825E1-C2E1-4A07-A61E-70EB9D1031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50124-874B-4CD3-9E08-C2AD853AE7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7C1B3F-1ACF-4DEE-A3AC-2D349C193C0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87280" y="692280"/>
            <a:ext cx="691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Times New Roman"/>
              </a:rPr>
              <a:t>Additional table 1.</a:t>
            </a:r>
            <a:r>
              <a:rPr b="0" lang="es-ES" sz="1800" spc="-1" strike="noStrike">
                <a:solidFill>
                  <a:srgbClr val="000000"/>
                </a:solidFill>
                <a:latin typeface="Times New Roman"/>
              </a:rPr>
              <a:t>  Primary antibodies us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116000" y="1197000"/>
          <a:ext cx="6105600" cy="4284720"/>
        </p:xfrm>
        <a:graphic>
          <a:graphicData uri="http://schemas.openxmlformats.org/drawingml/2006/table">
            <a:tbl>
              <a:tblPr/>
              <a:tblGrid>
                <a:gridCol w="1154160"/>
                <a:gridCol w="1077840"/>
                <a:gridCol w="1511280"/>
                <a:gridCol w="2362320"/>
              </a:tblGrid>
              <a:tr h="5198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o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centr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vided b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24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D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G2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/3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D, Franklin Lakes, NJ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198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lcycl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Y-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/5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gma, St. Louis, M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10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F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A-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/3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ymed, Carlsbad, 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P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-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/3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nta Cruz Biotech, Santa Cruz, 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06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-ki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E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/3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ymed, Carlsbad, CA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ox2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-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/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nta Cruz Biotech., Santa Cruz, 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06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imen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edilu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vocastra, Newcastle, U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24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CG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XP-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/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exis Biochemicals, Lausen, C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24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1/61/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edilu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vocastra, Newcastle, U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ox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B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/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&amp;D systems,Minneapolis, M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24T16:47:34Z</dcterms:created>
  <dc:creator>Administrador</dc:creator>
  <dc:description/>
  <dc:language>en-US</dc:language>
  <cp:lastModifiedBy>sacosta</cp:lastModifiedBy>
  <dcterms:modified xsi:type="dcterms:W3CDTF">2008-10-22T09:48:36Z</dcterms:modified>
  <cp:revision>18</cp:revision>
  <dc:subject/>
  <dc:title>Diapositiva 1</dc:title>
</cp:coreProperties>
</file>